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16" y="3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B43D8A-8335-49B3-88C0-B37DA6029AD9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0B6B25-901E-4155-82AA-5B3F0E4C66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3662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B6B25-901E-4155-82AA-5B3F0E4C66A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9496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>
  <p:cSld name="标题和表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表格占位符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525963"/>
          </a:xfrm>
        </p:spPr>
        <p:txBody>
          <a:bodyPr/>
          <a:lstStyle/>
          <a:p>
            <a:pPr lvl="0"/>
            <a:endParaRPr lang="zh-CN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9F9547-25A7-45D6-B593-88649BA35CE4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713133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367"/>
          <p:cNvSpPr>
            <a:spLocks noGrp="1" noChangeArrowheads="1"/>
          </p:cNvSpPr>
          <p:nvPr>
            <p:ph type="title"/>
          </p:nvPr>
        </p:nvSpPr>
        <p:spPr>
          <a:xfrm>
            <a:off x="2092325" y="649288"/>
            <a:ext cx="5327650" cy="258762"/>
          </a:xfrm>
        </p:spPr>
        <p:txBody>
          <a:bodyPr/>
          <a:lstStyle/>
          <a:p>
            <a:pPr algn="l"/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CrI of raw materials in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wheat and rice 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samples</a:t>
            </a:r>
          </a:p>
        </p:txBody>
      </p:sp>
      <p:sp>
        <p:nvSpPr>
          <p:cNvPr id="10243" name="Rectangle 368"/>
          <p:cNvSpPr>
            <a:spLocks noChangeArrowheads="1"/>
          </p:cNvSpPr>
          <p:nvPr/>
        </p:nvSpPr>
        <p:spPr bwMode="auto">
          <a:xfrm>
            <a:off x="2110235" y="5477743"/>
            <a:ext cx="6566221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altLang="en-US" sz="1400" b="1" baseline="30000" dirty="0">
                <a:latin typeface="Arial" pitchFamily="34" charset="0"/>
                <a:cs typeface="Arial" pitchFamily="34" charset="0"/>
                <a:sym typeface="宋体" pitchFamily="2" charset="-122"/>
              </a:rPr>
              <a:t>&amp;</a:t>
            </a:r>
            <a:r>
              <a:rPr lang="en-GB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,</a:t>
            </a:r>
            <a:r>
              <a:rPr lang="zh-CN" altLang="en-US" sz="1000" b="1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 </a:t>
            </a:r>
            <a:r>
              <a:rPr lang="zh-CN" altLang="en-US" sz="1000" b="1" baseline="0" dirty="0" smtClean="0">
                <a:latin typeface="Arial" pitchFamily="34" charset="0"/>
                <a:cs typeface="Arial" pitchFamily="34" charset="0"/>
                <a:sym typeface="宋体" pitchFamily="2" charset="-122"/>
              </a:rPr>
              <a:t> </a:t>
            </a:r>
            <a:r>
              <a:rPr lang="zh-CN" altLang="en-US" sz="1000" baseline="0" dirty="0" smtClean="0">
                <a:latin typeface="Arial" pitchFamily="34" charset="0"/>
                <a:cs typeface="Arial" pitchFamily="34" charset="0"/>
                <a:sym typeface="宋体" pitchFamily="2" charset="-122"/>
              </a:rPr>
              <a:t>(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H) or (L) Indicated the sample in the pair with high (H) or low (L)  biomass digestibility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;</a:t>
            </a:r>
            <a:endParaRPr lang="zh-CN" altLang="en-US" sz="1000" baseline="0" dirty="0">
              <a:latin typeface="Arial" pitchFamily="34" charset="0"/>
              <a:cs typeface="Arial" pitchFamily="34" charset="0"/>
              <a:sym typeface="宋体" pitchFamily="2" charset="-122"/>
            </a:endParaRPr>
          </a:p>
          <a:p>
            <a:r>
              <a:rPr lang="zh-CN" altLang="en-US" sz="1400" b="1" baseline="30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@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,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 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rI method was detected at ±0.05~0.15 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using five representative samples;</a:t>
            </a:r>
            <a:endParaRPr lang="zh-CN" altLang="en-US" sz="1000" baseline="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r>
              <a:rPr lang="zh-CN" altLang="en-US" sz="1400" b="1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,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zh-CN" altLang="en-US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zh-CN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r>
              <a:rPr lang="en-GB" altLang="en-US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rcentage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f the increased or decreased level at pair: subtraction of two samples divided by 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ow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alue at </a:t>
            </a:r>
            <a:r>
              <a:rPr lang="en-GB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ir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</a:p>
        </p:txBody>
      </p:sp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2179638" y="908050"/>
          <a:ext cx="3613152" cy="4549784"/>
        </p:xfrm>
        <a:graphic>
          <a:graphicData uri="http://schemas.openxmlformats.org/drawingml/2006/table">
            <a:tbl>
              <a:tblPr/>
              <a:tblGrid>
                <a:gridCol w="903288"/>
                <a:gridCol w="903288"/>
                <a:gridCol w="903288"/>
                <a:gridCol w="903288"/>
              </a:tblGrid>
              <a:tr h="2517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ai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mp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rI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-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27(H)</a:t>
                      </a:r>
                      <a:r>
                        <a:rPr lang="en-US" sz="12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amp;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3</a:t>
                      </a:r>
                      <a:r>
                        <a:rPr lang="en-US" altLang="zh-CN" sz="1200" b="1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@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4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kumimoji="0" lang="zh-CN" alt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*</a:t>
                      </a:r>
                      <a:endParaRPr lang="en-US" altLang="zh-CN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98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-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1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9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4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-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107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6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93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-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1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71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-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107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7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58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-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46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4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4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I-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sfc27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6.6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71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I-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sfc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1.5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85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I-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sfc3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.7</a:t>
                      </a:r>
                      <a:r>
                        <a:rPr kumimoji="0" lang="zh-CN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sym typeface="Arial" charset="0"/>
                        </a:rPr>
                        <a:t>%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24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Lq2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37764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7</Words>
  <Application>Microsoft Office PowerPoint</Application>
  <PresentationFormat>全屏显示(4:3)</PresentationFormat>
  <Paragraphs>6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3. CrI of raw materials in wheat and rice sampl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3. CrI of raw materials in wheat and rice samples</dc:title>
  <cp:lastModifiedBy>微软用户</cp:lastModifiedBy>
  <cp:revision>3</cp:revision>
  <dcterms:modified xsi:type="dcterms:W3CDTF">2013-09-04T07:14:57Z</dcterms:modified>
</cp:coreProperties>
</file>